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F49DCC-46DA-4D69-BCCA-E07F5B9B26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7CCF91-DED9-40F1-95DD-8A2C21C691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6C549-556E-4A83-A015-1780CF4A47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A7E97-4CEA-4DE2-B6D6-C5344938AA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C80A43-FBA9-4441-9A35-2351B5BD20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57C1A-19C4-4880-A1EB-563D1DE2B5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47ACE2-667C-4D47-9F45-9A1CDC0AA7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9C199A-08DF-4596-8D91-206D527AE0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347C9-F720-4453-B6B2-2CBC042044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D49337-0DA9-47A4-BD13-C0DEA81BA4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CE1F0-E05D-432F-878C-0903858F9D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458E7-46B1-465B-9E9C-9BBC32E7E9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808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808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EEDA19-5E2F-48C9-B7DE-11DCC8A0CA8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453960"/>
          <a:ext cx="9144000" cy="46832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453960"/>
                    <a:ext cx="9144000" cy="4683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0" y="4925880"/>
            <a:ext cx="9144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: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e differentially expressed genes were categorized according to GO biological processes; 10% are involved in transcription, 9% in signal transduction, 6% are involved in cell proliferation, differentiation and regulation of cell growth, 5% in transport, 10% in metabolism, 5% in immune responsiveness, 4% in electron transport mechanisms, 23% were involved in ‘other’ processes and 28% encode genes of unknown function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0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1-10-10T23:00:19Z</dcterms:created>
  <dc:creator>John Conour</dc:creator>
  <dc:description/>
  <dc:language>en-US</dc:language>
  <cp:lastModifiedBy>shankarc</cp:lastModifiedBy>
  <cp:lastPrinted>2005-04-11T20:15:25Z</cp:lastPrinted>
  <dcterms:modified xsi:type="dcterms:W3CDTF">2007-06-21T18:29:15Z</dcterms:modified>
  <cp:revision>1089</cp:revision>
  <dc:subject/>
  <dc:title>Introduction</dc:title>
</cp:coreProperties>
</file>